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56" d="100"/>
          <a:sy n="56" d="100"/>
        </p:scale>
        <p:origin x="-235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79BB-2EE6-F443-8D36-37C7B4497878}" type="datetimeFigureOut">
              <a:rPr lang="en-US" smtClean="0"/>
              <a:t>3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05151-2324-5941-B861-1930CB506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316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79BB-2EE6-F443-8D36-37C7B4497878}" type="datetimeFigureOut">
              <a:rPr lang="en-US" smtClean="0"/>
              <a:t>3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05151-2324-5941-B861-1930CB506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7814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79BB-2EE6-F443-8D36-37C7B4497878}" type="datetimeFigureOut">
              <a:rPr lang="en-US" smtClean="0"/>
              <a:t>3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05151-2324-5941-B861-1930CB506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932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79BB-2EE6-F443-8D36-37C7B4497878}" type="datetimeFigureOut">
              <a:rPr lang="en-US" smtClean="0"/>
              <a:t>3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05151-2324-5941-B861-1930CB506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2126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79BB-2EE6-F443-8D36-37C7B4497878}" type="datetimeFigureOut">
              <a:rPr lang="en-US" smtClean="0"/>
              <a:t>3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05151-2324-5941-B861-1930CB506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273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79BB-2EE6-F443-8D36-37C7B4497878}" type="datetimeFigureOut">
              <a:rPr lang="en-US" smtClean="0"/>
              <a:t>3/2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05151-2324-5941-B861-1930CB506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841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79BB-2EE6-F443-8D36-37C7B4497878}" type="datetimeFigureOut">
              <a:rPr lang="en-US" smtClean="0"/>
              <a:t>3/21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05151-2324-5941-B861-1930CB506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1443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79BB-2EE6-F443-8D36-37C7B4497878}" type="datetimeFigureOut">
              <a:rPr lang="en-US" smtClean="0"/>
              <a:t>3/21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05151-2324-5941-B861-1930CB506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2571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79BB-2EE6-F443-8D36-37C7B4497878}" type="datetimeFigureOut">
              <a:rPr lang="en-US" smtClean="0"/>
              <a:t>3/21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05151-2324-5941-B861-1930CB506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853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79BB-2EE6-F443-8D36-37C7B4497878}" type="datetimeFigureOut">
              <a:rPr lang="en-US" smtClean="0"/>
              <a:t>3/2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05151-2324-5941-B861-1930CB506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14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79BB-2EE6-F443-8D36-37C7B4497878}" type="datetimeFigureOut">
              <a:rPr lang="en-US" smtClean="0"/>
              <a:t>3/2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05151-2324-5941-B861-1930CB506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812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BF79BB-2EE6-F443-8D36-37C7B4497878}" type="datetimeFigureOut">
              <a:rPr lang="en-US" smtClean="0"/>
              <a:t>3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905151-2324-5941-B861-1930CB506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489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2" y="76200"/>
            <a:ext cx="3276600" cy="3276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3" name="Group 2"/>
          <p:cNvGrpSpPr/>
          <p:nvPr/>
        </p:nvGrpSpPr>
        <p:grpSpPr>
          <a:xfrm>
            <a:off x="2895600" y="709610"/>
            <a:ext cx="569387" cy="2278776"/>
            <a:chOff x="2895600" y="4214810"/>
            <a:chExt cx="569387" cy="2278776"/>
          </a:xfrm>
        </p:grpSpPr>
        <p:sp>
          <p:nvSpPr>
            <p:cNvPr id="4" name="TextBox 3"/>
            <p:cNvSpPr txBox="1"/>
            <p:nvPr/>
          </p:nvSpPr>
          <p:spPr>
            <a:xfrm>
              <a:off x="2895600" y="4214810"/>
              <a:ext cx="569387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POMGNT2</a:t>
              </a:r>
              <a:endParaRPr lang="en-US" sz="700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895600" y="4374712"/>
              <a:ext cx="391454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DAG1</a:t>
              </a:r>
              <a:endParaRPr lang="en-US" sz="7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895600" y="4534614"/>
              <a:ext cx="421910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LARGE</a:t>
              </a:r>
              <a:endParaRPr lang="en-US" sz="7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895600" y="4694516"/>
              <a:ext cx="46358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SGK196</a:t>
              </a:r>
              <a:endParaRPr lang="en-US" sz="7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895600" y="4854418"/>
              <a:ext cx="373820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FKTN</a:t>
              </a:r>
              <a:endParaRPr lang="en-US" sz="7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895600" y="5014320"/>
              <a:ext cx="349776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ISPD</a:t>
              </a:r>
              <a:endParaRPr lang="en-US" sz="7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895600" y="5174222"/>
              <a:ext cx="569387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B</a:t>
              </a:r>
              <a:r>
                <a:rPr lang="en-US" sz="700" dirty="0" smtClean="0"/>
                <a:t>3GALNT2</a:t>
              </a:r>
              <a:endParaRPr lang="en-US" sz="7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895600" y="5334124"/>
              <a:ext cx="470000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TMEM5</a:t>
              </a:r>
              <a:endParaRPr lang="en-US" sz="7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895600" y="5494026"/>
              <a:ext cx="455574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POMT2</a:t>
              </a:r>
              <a:endParaRPr lang="en-US" sz="7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895600" y="5653928"/>
              <a:ext cx="36740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FKRP</a:t>
              </a:r>
              <a:endParaRPr lang="en-US" sz="7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895600" y="5813830"/>
              <a:ext cx="455574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POMT1</a:t>
              </a:r>
              <a:endParaRPr lang="en-US" sz="7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895600" y="5973732"/>
              <a:ext cx="497252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GYLTL1B</a:t>
              </a:r>
              <a:endParaRPr lang="en-US" sz="7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895600" y="6133634"/>
              <a:ext cx="47961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B3GNT1</a:t>
              </a:r>
              <a:endParaRPr lang="en-US" sz="7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895600" y="6293531"/>
              <a:ext cx="569387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POMGNT1</a:t>
              </a:r>
              <a:endParaRPr lang="en-US" sz="700" dirty="0"/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634080" y="2971799"/>
            <a:ext cx="2278776" cy="569387"/>
            <a:chOff x="4038600" y="5131668"/>
            <a:chExt cx="2278776" cy="569387"/>
          </a:xfrm>
        </p:grpSpPr>
        <p:sp>
          <p:nvSpPr>
            <p:cNvPr id="19" name="TextBox 18"/>
            <p:cNvSpPr txBox="1"/>
            <p:nvPr/>
          </p:nvSpPr>
          <p:spPr>
            <a:xfrm rot="16200000">
              <a:off x="3853934" y="5316334"/>
              <a:ext cx="569387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POMGNT1</a:t>
              </a:r>
              <a:endParaRPr lang="en-US" sz="700" dirty="0"/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4058720" y="5271450"/>
              <a:ext cx="47961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B3GNT1</a:t>
              </a:r>
              <a:endParaRPr lang="en-US" sz="700" dirty="0"/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4209805" y="5280267"/>
              <a:ext cx="497252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GYLTL1B</a:t>
              </a:r>
              <a:endParaRPr lang="en-US" sz="700" dirty="0"/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4390546" y="5259428"/>
              <a:ext cx="455574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POMT1</a:t>
              </a:r>
              <a:endParaRPr lang="en-US" sz="700" dirty="0"/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4594531" y="5215345"/>
              <a:ext cx="36740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FKRP</a:t>
              </a:r>
              <a:endParaRPr lang="en-US" sz="700" dirty="0"/>
            </a:p>
          </p:txBody>
        </p:sp>
        <p:sp>
          <p:nvSpPr>
            <p:cNvPr id="24" name="TextBox 23"/>
            <p:cNvSpPr txBox="1"/>
            <p:nvPr/>
          </p:nvSpPr>
          <p:spPr>
            <a:xfrm rot="16200000">
              <a:off x="4710350" y="5259428"/>
              <a:ext cx="455574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POMT2</a:t>
              </a:r>
              <a:endParaRPr lang="en-US" sz="700" dirty="0"/>
            </a:p>
          </p:txBody>
        </p:sp>
        <p:sp>
          <p:nvSpPr>
            <p:cNvPr id="25" name="TextBox 24"/>
            <p:cNvSpPr txBox="1"/>
            <p:nvPr/>
          </p:nvSpPr>
          <p:spPr>
            <a:xfrm rot="16200000">
              <a:off x="4863039" y="5266641"/>
              <a:ext cx="470000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TMEM5</a:t>
              </a:r>
              <a:endParaRPr lang="en-US" sz="700" dirty="0"/>
            </a:p>
          </p:txBody>
        </p:sp>
        <p:sp>
          <p:nvSpPr>
            <p:cNvPr id="26" name="TextBox 25"/>
            <p:cNvSpPr txBox="1"/>
            <p:nvPr/>
          </p:nvSpPr>
          <p:spPr>
            <a:xfrm rot="16200000">
              <a:off x="4973248" y="5316334"/>
              <a:ext cx="569387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B3GALNT2</a:t>
              </a:r>
              <a:endParaRPr lang="en-US" sz="700" dirty="0"/>
            </a:p>
          </p:txBody>
        </p:sp>
        <p:sp>
          <p:nvSpPr>
            <p:cNvPr id="27" name="TextBox 26"/>
            <p:cNvSpPr txBox="1"/>
            <p:nvPr/>
          </p:nvSpPr>
          <p:spPr>
            <a:xfrm rot="16200000">
              <a:off x="5242955" y="5206529"/>
              <a:ext cx="349776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ISPD</a:t>
              </a:r>
              <a:endParaRPr lang="en-US" sz="700" dirty="0"/>
            </a:p>
          </p:txBody>
        </p:sp>
        <p:sp>
          <p:nvSpPr>
            <p:cNvPr id="28" name="TextBox 27"/>
            <p:cNvSpPr txBox="1"/>
            <p:nvPr/>
          </p:nvSpPr>
          <p:spPr>
            <a:xfrm rot="16200000">
              <a:off x="5390835" y="5218551"/>
              <a:ext cx="373820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FKTN</a:t>
              </a:r>
              <a:endParaRPr lang="en-US" sz="700" dirty="0"/>
            </a:p>
          </p:txBody>
        </p:sp>
        <p:sp>
          <p:nvSpPr>
            <p:cNvPr id="29" name="TextBox 28"/>
            <p:cNvSpPr txBox="1"/>
            <p:nvPr/>
          </p:nvSpPr>
          <p:spPr>
            <a:xfrm rot="16200000">
              <a:off x="5505853" y="5263435"/>
              <a:ext cx="46358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SGK196</a:t>
              </a:r>
              <a:endParaRPr lang="en-US" sz="700" dirty="0"/>
            </a:p>
          </p:txBody>
        </p:sp>
        <p:sp>
          <p:nvSpPr>
            <p:cNvPr id="30" name="TextBox 29"/>
            <p:cNvSpPr txBox="1"/>
            <p:nvPr/>
          </p:nvSpPr>
          <p:spPr>
            <a:xfrm rot="16200000">
              <a:off x="5686594" y="5242596"/>
              <a:ext cx="421910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LARGE</a:t>
              </a:r>
              <a:endParaRPr lang="en-US" sz="700" dirty="0"/>
            </a:p>
          </p:txBody>
        </p:sp>
        <p:sp>
          <p:nvSpPr>
            <p:cNvPr id="31" name="TextBox 30"/>
            <p:cNvSpPr txBox="1"/>
            <p:nvPr/>
          </p:nvSpPr>
          <p:spPr>
            <a:xfrm rot="16200000">
              <a:off x="5861724" y="5227368"/>
              <a:ext cx="391454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DAG1</a:t>
              </a:r>
              <a:endParaRPr lang="en-US" sz="700" dirty="0"/>
            </a:p>
          </p:txBody>
        </p:sp>
        <p:sp>
          <p:nvSpPr>
            <p:cNvPr id="32" name="TextBox 31"/>
            <p:cNvSpPr txBox="1"/>
            <p:nvPr/>
          </p:nvSpPr>
          <p:spPr>
            <a:xfrm rot="16200000">
              <a:off x="5932655" y="5316334"/>
              <a:ext cx="569387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POMGNT2</a:t>
              </a:r>
              <a:endParaRPr lang="en-US" sz="700" dirty="0"/>
            </a:p>
          </p:txBody>
        </p:sp>
      </p:grpSp>
      <p:pic>
        <p:nvPicPr>
          <p:cNvPr id="34" name="Picture 33"/>
          <p:cNvPicPr>
            <a:picLocks noChangeAspect="1"/>
          </p:cNvPicPr>
          <p:nvPr/>
        </p:nvPicPr>
        <p:blipFill rotWithShape="1">
          <a:blip r:embed="rId3"/>
          <a:srcRect l="77539" t="17845" r="15704" b="2284"/>
          <a:stretch/>
        </p:blipFill>
        <p:spPr>
          <a:xfrm>
            <a:off x="3505200" y="745067"/>
            <a:ext cx="350710" cy="27601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433765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Macintosh PowerPoint</Application>
  <PresentationFormat>On-screen Show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Miller</dc:creator>
  <cp:lastModifiedBy>Michael Miller</cp:lastModifiedBy>
  <cp:revision>1</cp:revision>
  <dcterms:created xsi:type="dcterms:W3CDTF">2015-03-21T16:36:12Z</dcterms:created>
  <dcterms:modified xsi:type="dcterms:W3CDTF">2015-03-21T16:36:44Z</dcterms:modified>
</cp:coreProperties>
</file>